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00FF"/>
    <a:srgbClr val="CC00FF"/>
    <a:srgbClr val="FFCC99"/>
    <a:srgbClr val="FFCC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1930" autoAdjust="0"/>
    <p:restoredTop sz="99429" autoAdjust="0"/>
  </p:normalViewPr>
  <p:slideViewPr>
    <p:cSldViewPr>
      <p:cViewPr varScale="1">
        <p:scale>
          <a:sx n="83" d="100"/>
          <a:sy n="83" d="100"/>
        </p:scale>
        <p:origin x="1272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 nodules papier'!$D$4</c:f>
              <c:strCache>
                <c:ptCount val="1"/>
                <c:pt idx="0">
                  <c:v>ORS 278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 nodules papier'!$J$5:$J$21</c:f>
                <c:numCache>
                  <c:formatCode>General</c:formatCode>
                  <c:ptCount val="17"/>
                  <c:pt idx="0">
                    <c:v>1.3038404810405309</c:v>
                  </c:pt>
                  <c:pt idx="1">
                    <c:v>2.7386127875258306</c:v>
                  </c:pt>
                  <c:pt idx="2">
                    <c:v>3.7815340802378072</c:v>
                  </c:pt>
                  <c:pt idx="3">
                    <c:v>3.5355339059327378</c:v>
                  </c:pt>
                  <c:pt idx="4">
                    <c:v>2.6299556396765835</c:v>
                  </c:pt>
                  <c:pt idx="5">
                    <c:v>6.180614856144981</c:v>
                  </c:pt>
                  <c:pt idx="6">
                    <c:v>1.6431676725154991</c:v>
                  </c:pt>
                  <c:pt idx="7">
                    <c:v>3.3466401061363005</c:v>
                  </c:pt>
                  <c:pt idx="8">
                    <c:v>6.6483080554378677</c:v>
                  </c:pt>
                  <c:pt idx="9">
                    <c:v>4.0620192023179804</c:v>
                  </c:pt>
                  <c:pt idx="10">
                    <c:v>5.0695167422546294</c:v>
                  </c:pt>
                  <c:pt idx="11">
                    <c:v>4.0865633483405084</c:v>
                  </c:pt>
                  <c:pt idx="12">
                    <c:v>1.9235384061671315</c:v>
                  </c:pt>
                  <c:pt idx="13">
                    <c:v>2.1679483388678773</c:v>
                  </c:pt>
                  <c:pt idx="14">
                    <c:v>4.4721359549995796</c:v>
                  </c:pt>
                  <c:pt idx="15">
                    <c:v>1.1401754250991367</c:v>
                  </c:pt>
                  <c:pt idx="16">
                    <c:v>1.707825127659933</c:v>
                  </c:pt>
                </c:numCache>
              </c:numRef>
            </c:plus>
            <c:minus>
              <c:numRef>
                <c:f>'n nodules papier'!$J$5:$J$21</c:f>
                <c:numCache>
                  <c:formatCode>General</c:formatCode>
                  <c:ptCount val="17"/>
                  <c:pt idx="0">
                    <c:v>1.3038404810405309</c:v>
                  </c:pt>
                  <c:pt idx="1">
                    <c:v>2.7386127875258306</c:v>
                  </c:pt>
                  <c:pt idx="2">
                    <c:v>3.7815340802378072</c:v>
                  </c:pt>
                  <c:pt idx="3">
                    <c:v>3.5355339059327378</c:v>
                  </c:pt>
                  <c:pt idx="4">
                    <c:v>2.6299556396765835</c:v>
                  </c:pt>
                  <c:pt idx="5">
                    <c:v>6.180614856144981</c:v>
                  </c:pt>
                  <c:pt idx="6">
                    <c:v>1.6431676725154991</c:v>
                  </c:pt>
                  <c:pt idx="7">
                    <c:v>3.3466401061363005</c:v>
                  </c:pt>
                  <c:pt idx="8">
                    <c:v>6.6483080554378677</c:v>
                  </c:pt>
                  <c:pt idx="9">
                    <c:v>4.0620192023179804</c:v>
                  </c:pt>
                  <c:pt idx="10">
                    <c:v>5.0695167422546294</c:v>
                  </c:pt>
                  <c:pt idx="11">
                    <c:v>4.0865633483405084</c:v>
                  </c:pt>
                  <c:pt idx="12">
                    <c:v>1.9235384061671315</c:v>
                  </c:pt>
                  <c:pt idx="13">
                    <c:v>2.1679483388678773</c:v>
                  </c:pt>
                  <c:pt idx="14">
                    <c:v>4.4721359549995796</c:v>
                  </c:pt>
                  <c:pt idx="15">
                    <c:v>1.1401754250991367</c:v>
                  </c:pt>
                  <c:pt idx="16">
                    <c:v>1.7078251276599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n nodules papier'!$B$5:$C$21</c:f>
              <c:multiLvlStrCache>
                <c:ptCount val="17"/>
                <c:lvl>
                  <c:pt idx="0">
                    <c:v>n°75</c:v>
                  </c:pt>
                  <c:pt idx="1">
                    <c:v>n°80</c:v>
                  </c:pt>
                  <c:pt idx="2">
                    <c:v>n°101</c:v>
                  </c:pt>
                  <c:pt idx="3">
                    <c:v>n°108</c:v>
                  </c:pt>
                  <c:pt idx="4">
                    <c:v>n°109</c:v>
                  </c:pt>
                  <c:pt idx="5">
                    <c:v>n°20</c:v>
                  </c:pt>
                  <c:pt idx="6">
                    <c:v>n°92</c:v>
                  </c:pt>
                  <c:pt idx="7">
                    <c:v>n°95</c:v>
                  </c:pt>
                  <c:pt idx="8">
                    <c:v>n°105</c:v>
                  </c:pt>
                  <c:pt idx="9">
                    <c:v>n°19</c:v>
                  </c:pt>
                  <c:pt idx="10">
                    <c:v>n°29</c:v>
                  </c:pt>
                  <c:pt idx="11">
                    <c:v>n°44</c:v>
                  </c:pt>
                  <c:pt idx="12">
                    <c:v>n°93</c:v>
                  </c:pt>
                  <c:pt idx="13">
                    <c:v>n°97</c:v>
                  </c:pt>
                  <c:pt idx="14">
                    <c:v>n°98</c:v>
                  </c:pt>
                  <c:pt idx="15">
                    <c:v>n°22</c:v>
                  </c:pt>
                  <c:pt idx="16">
                    <c:v>n°100</c:v>
                  </c:pt>
                </c:lvl>
                <c:lvl>
                  <c:pt idx="0">
                    <c:v>A. evenia ss</c:v>
                  </c:pt>
                  <c:pt idx="5">
                    <c:v>A. indica 4x</c:v>
                  </c:pt>
                  <c:pt idx="9">
                    <c:v>A. indica 6x                                                  Africa</c:v>
                  </c:pt>
                  <c:pt idx="15">
                    <c:v>A. indica 6x Australia</c:v>
                  </c:pt>
                </c:lvl>
              </c:multiLvlStrCache>
            </c:multiLvlStrRef>
          </c:cat>
          <c:val>
            <c:numRef>
              <c:f>'n nodules papier'!$D$5:$D$21</c:f>
              <c:numCache>
                <c:formatCode>General</c:formatCode>
                <c:ptCount val="17"/>
                <c:pt idx="0">
                  <c:v>5.8</c:v>
                </c:pt>
                <c:pt idx="1">
                  <c:v>16</c:v>
                </c:pt>
                <c:pt idx="2">
                  <c:v>9.4</c:v>
                </c:pt>
                <c:pt idx="3">
                  <c:v>14</c:v>
                </c:pt>
                <c:pt idx="4">
                  <c:v>10.75</c:v>
                </c:pt>
                <c:pt idx="5">
                  <c:v>23.2</c:v>
                </c:pt>
                <c:pt idx="6">
                  <c:v>9.8000000000000007</c:v>
                </c:pt>
                <c:pt idx="7">
                  <c:v>17.2</c:v>
                </c:pt>
                <c:pt idx="8">
                  <c:v>31.2</c:v>
                </c:pt>
                <c:pt idx="9">
                  <c:v>24</c:v>
                </c:pt>
                <c:pt idx="10">
                  <c:v>17.8</c:v>
                </c:pt>
                <c:pt idx="11">
                  <c:v>19.8</c:v>
                </c:pt>
                <c:pt idx="12">
                  <c:v>12.2</c:v>
                </c:pt>
                <c:pt idx="13">
                  <c:v>12.8</c:v>
                </c:pt>
                <c:pt idx="14">
                  <c:v>14</c:v>
                </c:pt>
                <c:pt idx="15">
                  <c:v>8.6</c:v>
                </c:pt>
                <c:pt idx="16">
                  <c:v>6.75</c:v>
                </c:pt>
              </c:numCache>
            </c:numRef>
          </c:val>
        </c:ser>
        <c:ser>
          <c:idx val="1"/>
          <c:order val="1"/>
          <c:tx>
            <c:strRef>
              <c:f>'n nodules papier'!$E$4</c:f>
              <c:strCache>
                <c:ptCount val="1"/>
                <c:pt idx="0">
                  <c:v>Btai1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 nodules papier'!$K$5:$K$21</c:f>
                <c:numCache>
                  <c:formatCode>General</c:formatCode>
                  <c:ptCount val="17"/>
                  <c:pt idx="0">
                    <c:v>3.4351128074635331</c:v>
                  </c:pt>
                  <c:pt idx="1">
                    <c:v>1.4832396974191335</c:v>
                  </c:pt>
                  <c:pt idx="2">
                    <c:v>1.949358868961792</c:v>
                  </c:pt>
                  <c:pt idx="3">
                    <c:v>3.4928498393145944</c:v>
                  </c:pt>
                  <c:pt idx="4">
                    <c:v>0.57735026918962573</c:v>
                  </c:pt>
                  <c:pt idx="5">
                    <c:v>3.4351128074635353</c:v>
                  </c:pt>
                  <c:pt idx="6">
                    <c:v>2.190890230020667</c:v>
                  </c:pt>
                  <c:pt idx="7">
                    <c:v>4.0987803063838335</c:v>
                  </c:pt>
                  <c:pt idx="8">
                    <c:v>3.50713558335003</c:v>
                  </c:pt>
                  <c:pt idx="9">
                    <c:v>4.5497252664309293</c:v>
                  </c:pt>
                  <c:pt idx="10">
                    <c:v>2.9664793948382671</c:v>
                  </c:pt>
                  <c:pt idx="11">
                    <c:v>6.5954529791364598</c:v>
                  </c:pt>
                  <c:pt idx="12">
                    <c:v>4.147288270665543</c:v>
                  </c:pt>
                  <c:pt idx="13">
                    <c:v>4.636809247747852</c:v>
                  </c:pt>
                  <c:pt idx="14">
                    <c:v>4.3931765272977605</c:v>
                  </c:pt>
                  <c:pt idx="15">
                    <c:v>3.6331804249169903</c:v>
                  </c:pt>
                  <c:pt idx="16">
                    <c:v>1.9235384061671352</c:v>
                  </c:pt>
                </c:numCache>
              </c:numRef>
            </c:plus>
            <c:minus>
              <c:numRef>
                <c:f>'n nodules papier'!$K$5:$K$21</c:f>
                <c:numCache>
                  <c:formatCode>General</c:formatCode>
                  <c:ptCount val="17"/>
                  <c:pt idx="0">
                    <c:v>3.4351128074635331</c:v>
                  </c:pt>
                  <c:pt idx="1">
                    <c:v>1.4832396974191335</c:v>
                  </c:pt>
                  <c:pt idx="2">
                    <c:v>1.949358868961792</c:v>
                  </c:pt>
                  <c:pt idx="3">
                    <c:v>3.4928498393145944</c:v>
                  </c:pt>
                  <c:pt idx="4">
                    <c:v>0.57735026918962573</c:v>
                  </c:pt>
                  <c:pt idx="5">
                    <c:v>3.4351128074635353</c:v>
                  </c:pt>
                  <c:pt idx="6">
                    <c:v>2.190890230020667</c:v>
                  </c:pt>
                  <c:pt idx="7">
                    <c:v>4.0987803063838335</c:v>
                  </c:pt>
                  <c:pt idx="8">
                    <c:v>3.50713558335003</c:v>
                  </c:pt>
                  <c:pt idx="9">
                    <c:v>4.5497252664309293</c:v>
                  </c:pt>
                  <c:pt idx="10">
                    <c:v>2.9664793948382671</c:v>
                  </c:pt>
                  <c:pt idx="11">
                    <c:v>6.5954529791364598</c:v>
                  </c:pt>
                  <c:pt idx="12">
                    <c:v>4.147288270665543</c:v>
                  </c:pt>
                  <c:pt idx="13">
                    <c:v>4.636809247747852</c:v>
                  </c:pt>
                  <c:pt idx="14">
                    <c:v>4.3931765272977605</c:v>
                  </c:pt>
                  <c:pt idx="15">
                    <c:v>3.6331804249169903</c:v>
                  </c:pt>
                  <c:pt idx="16">
                    <c:v>1.92353840616713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n nodules papier'!$B$5:$C$21</c:f>
              <c:multiLvlStrCache>
                <c:ptCount val="17"/>
                <c:lvl>
                  <c:pt idx="0">
                    <c:v>n°75</c:v>
                  </c:pt>
                  <c:pt idx="1">
                    <c:v>n°80</c:v>
                  </c:pt>
                  <c:pt idx="2">
                    <c:v>n°101</c:v>
                  </c:pt>
                  <c:pt idx="3">
                    <c:v>n°108</c:v>
                  </c:pt>
                  <c:pt idx="4">
                    <c:v>n°109</c:v>
                  </c:pt>
                  <c:pt idx="5">
                    <c:v>n°20</c:v>
                  </c:pt>
                  <c:pt idx="6">
                    <c:v>n°92</c:v>
                  </c:pt>
                  <c:pt idx="7">
                    <c:v>n°95</c:v>
                  </c:pt>
                  <c:pt idx="8">
                    <c:v>n°105</c:v>
                  </c:pt>
                  <c:pt idx="9">
                    <c:v>n°19</c:v>
                  </c:pt>
                  <c:pt idx="10">
                    <c:v>n°29</c:v>
                  </c:pt>
                  <c:pt idx="11">
                    <c:v>n°44</c:v>
                  </c:pt>
                  <c:pt idx="12">
                    <c:v>n°93</c:v>
                  </c:pt>
                  <c:pt idx="13">
                    <c:v>n°97</c:v>
                  </c:pt>
                  <c:pt idx="14">
                    <c:v>n°98</c:v>
                  </c:pt>
                  <c:pt idx="15">
                    <c:v>n°22</c:v>
                  </c:pt>
                  <c:pt idx="16">
                    <c:v>n°100</c:v>
                  </c:pt>
                </c:lvl>
                <c:lvl>
                  <c:pt idx="0">
                    <c:v>A. evenia ss</c:v>
                  </c:pt>
                  <c:pt idx="5">
                    <c:v>A. indica 4x</c:v>
                  </c:pt>
                  <c:pt idx="9">
                    <c:v>A. indica 6x                                                  Africa</c:v>
                  </c:pt>
                  <c:pt idx="15">
                    <c:v>A. indica 6x Australia</c:v>
                  </c:pt>
                </c:lvl>
              </c:multiLvlStrCache>
            </c:multiLvlStrRef>
          </c:cat>
          <c:val>
            <c:numRef>
              <c:f>'n nodules papier'!$E$5:$E$21</c:f>
              <c:numCache>
                <c:formatCode>General</c:formatCode>
                <c:ptCount val="17"/>
                <c:pt idx="0">
                  <c:v>6.4</c:v>
                </c:pt>
                <c:pt idx="1">
                  <c:v>7.2</c:v>
                </c:pt>
                <c:pt idx="2">
                  <c:v>8.6</c:v>
                </c:pt>
                <c:pt idx="3">
                  <c:v>16.2</c:v>
                </c:pt>
                <c:pt idx="4">
                  <c:v>13.5</c:v>
                </c:pt>
                <c:pt idx="5">
                  <c:v>18.399999999999999</c:v>
                </c:pt>
                <c:pt idx="6">
                  <c:v>10.6</c:v>
                </c:pt>
                <c:pt idx="7">
                  <c:v>20.399999999999999</c:v>
                </c:pt>
                <c:pt idx="8">
                  <c:v>25.4</c:v>
                </c:pt>
                <c:pt idx="9">
                  <c:v>18.8</c:v>
                </c:pt>
                <c:pt idx="10">
                  <c:v>18.600000000000001</c:v>
                </c:pt>
                <c:pt idx="11">
                  <c:v>19</c:v>
                </c:pt>
                <c:pt idx="12">
                  <c:v>14.2</c:v>
                </c:pt>
                <c:pt idx="13">
                  <c:v>18</c:v>
                </c:pt>
                <c:pt idx="14">
                  <c:v>13.6</c:v>
                </c:pt>
                <c:pt idx="15">
                  <c:v>8.8000000000000007</c:v>
                </c:pt>
                <c:pt idx="16">
                  <c:v>6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04250096"/>
        <c:axId val="304250488"/>
      </c:barChart>
      <c:catAx>
        <c:axId val="304250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04250488"/>
        <c:crosses val="autoZero"/>
        <c:auto val="1"/>
        <c:lblAlgn val="ctr"/>
        <c:lblOffset val="100"/>
        <c:noMultiLvlLbl val="0"/>
      </c:catAx>
      <c:valAx>
        <c:axId val="304250488"/>
        <c:scaling>
          <c:orientation val="minMax"/>
          <c:max val="4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 nodules/plant</a:t>
                </a:r>
              </a:p>
            </c:rich>
          </c:tx>
          <c:layout>
            <c:manualLayout>
              <c:xMode val="edge"/>
              <c:yMode val="edge"/>
              <c:x val="1.2461059190031152E-2"/>
              <c:y val="0.289325843615342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0425009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682048834804736"/>
          <c:y val="5.007612366211233E-2"/>
          <c:w val="0.12027185238208861"/>
          <c:h val="0.147570011692463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 nodules papier'!$D$4</c:f>
              <c:strCache>
                <c:ptCount val="1"/>
                <c:pt idx="0">
                  <c:v>ORS 278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 nodules papier'!$J$27:$J$43</c:f>
                <c:numCache>
                  <c:formatCode>General</c:formatCode>
                  <c:ptCount val="17"/>
                  <c:pt idx="0">
                    <c:v>6.46</c:v>
                  </c:pt>
                  <c:pt idx="1">
                    <c:v>7.28</c:v>
                  </c:pt>
                  <c:pt idx="2">
                    <c:v>15.07</c:v>
                  </c:pt>
                  <c:pt idx="3">
                    <c:v>5.88</c:v>
                  </c:pt>
                  <c:pt idx="4">
                    <c:v>6.08</c:v>
                  </c:pt>
                  <c:pt idx="5">
                    <c:v>6.13</c:v>
                  </c:pt>
                  <c:pt idx="6">
                    <c:v>10.97</c:v>
                  </c:pt>
                  <c:pt idx="7">
                    <c:v>14.88</c:v>
                  </c:pt>
                  <c:pt idx="8">
                    <c:v>21.78</c:v>
                  </c:pt>
                  <c:pt idx="9">
                    <c:v>14.37</c:v>
                  </c:pt>
                  <c:pt idx="10">
                    <c:v>28.94</c:v>
                  </c:pt>
                  <c:pt idx="11">
                    <c:v>16.32</c:v>
                  </c:pt>
                  <c:pt idx="12">
                    <c:v>6.55</c:v>
                  </c:pt>
                  <c:pt idx="13">
                    <c:v>25.81</c:v>
                  </c:pt>
                  <c:pt idx="14">
                    <c:v>44.01</c:v>
                  </c:pt>
                  <c:pt idx="15">
                    <c:v>9.76</c:v>
                  </c:pt>
                  <c:pt idx="16">
                    <c:v>13.03</c:v>
                  </c:pt>
                </c:numCache>
              </c:numRef>
            </c:plus>
            <c:minus>
              <c:numRef>
                <c:f>'n nodules papier'!$J$27:$J$43</c:f>
                <c:numCache>
                  <c:formatCode>General</c:formatCode>
                  <c:ptCount val="17"/>
                  <c:pt idx="0">
                    <c:v>6.46</c:v>
                  </c:pt>
                  <c:pt idx="1">
                    <c:v>7.28</c:v>
                  </c:pt>
                  <c:pt idx="2">
                    <c:v>15.07</c:v>
                  </c:pt>
                  <c:pt idx="3">
                    <c:v>5.88</c:v>
                  </c:pt>
                  <c:pt idx="4">
                    <c:v>6.08</c:v>
                  </c:pt>
                  <c:pt idx="5">
                    <c:v>6.13</c:v>
                  </c:pt>
                  <c:pt idx="6">
                    <c:v>10.97</c:v>
                  </c:pt>
                  <c:pt idx="7">
                    <c:v>14.88</c:v>
                  </c:pt>
                  <c:pt idx="8">
                    <c:v>21.78</c:v>
                  </c:pt>
                  <c:pt idx="9">
                    <c:v>14.37</c:v>
                  </c:pt>
                  <c:pt idx="10">
                    <c:v>28.94</c:v>
                  </c:pt>
                  <c:pt idx="11">
                    <c:v>16.32</c:v>
                  </c:pt>
                  <c:pt idx="12">
                    <c:v>6.55</c:v>
                  </c:pt>
                  <c:pt idx="13">
                    <c:v>25.81</c:v>
                  </c:pt>
                  <c:pt idx="14">
                    <c:v>44.01</c:v>
                  </c:pt>
                  <c:pt idx="15">
                    <c:v>9.76</c:v>
                  </c:pt>
                  <c:pt idx="16">
                    <c:v>13.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n nodules papier'!$B$5:$C$21</c:f>
              <c:multiLvlStrCache>
                <c:ptCount val="17"/>
                <c:lvl>
                  <c:pt idx="0">
                    <c:v>n°75</c:v>
                  </c:pt>
                  <c:pt idx="1">
                    <c:v>n°80</c:v>
                  </c:pt>
                  <c:pt idx="2">
                    <c:v>n°101</c:v>
                  </c:pt>
                  <c:pt idx="3">
                    <c:v>n°108</c:v>
                  </c:pt>
                  <c:pt idx="4">
                    <c:v>n°109</c:v>
                  </c:pt>
                  <c:pt idx="5">
                    <c:v>n°20</c:v>
                  </c:pt>
                  <c:pt idx="6">
                    <c:v>n°92</c:v>
                  </c:pt>
                  <c:pt idx="7">
                    <c:v>n°95</c:v>
                  </c:pt>
                  <c:pt idx="8">
                    <c:v>n°105</c:v>
                  </c:pt>
                  <c:pt idx="9">
                    <c:v>n°19</c:v>
                  </c:pt>
                  <c:pt idx="10">
                    <c:v>n°29</c:v>
                  </c:pt>
                  <c:pt idx="11">
                    <c:v>n°44</c:v>
                  </c:pt>
                  <c:pt idx="12">
                    <c:v>n°93</c:v>
                  </c:pt>
                  <c:pt idx="13">
                    <c:v>n°97</c:v>
                  </c:pt>
                  <c:pt idx="14">
                    <c:v>n°98</c:v>
                  </c:pt>
                  <c:pt idx="15">
                    <c:v>n°22</c:v>
                  </c:pt>
                  <c:pt idx="16">
                    <c:v>n°100</c:v>
                  </c:pt>
                </c:lvl>
                <c:lvl>
                  <c:pt idx="0">
                    <c:v>A. evenia ss</c:v>
                  </c:pt>
                  <c:pt idx="5">
                    <c:v>A. indica 4x</c:v>
                  </c:pt>
                  <c:pt idx="9">
                    <c:v>A. indica 6x                                                  Africa</c:v>
                  </c:pt>
                  <c:pt idx="15">
                    <c:v>A. indica 6x Australia</c:v>
                  </c:pt>
                </c:lvl>
              </c:multiLvlStrCache>
            </c:multiLvlStrRef>
          </c:cat>
          <c:val>
            <c:numRef>
              <c:f>'n nodules papier'!$D$27:$D$43</c:f>
              <c:numCache>
                <c:formatCode>General</c:formatCode>
                <c:ptCount val="17"/>
                <c:pt idx="0">
                  <c:v>61.7</c:v>
                </c:pt>
                <c:pt idx="1">
                  <c:v>76.2</c:v>
                </c:pt>
                <c:pt idx="2">
                  <c:v>36.47</c:v>
                </c:pt>
                <c:pt idx="3">
                  <c:v>33.97</c:v>
                </c:pt>
                <c:pt idx="4">
                  <c:v>47.24</c:v>
                </c:pt>
                <c:pt idx="5">
                  <c:v>60.19</c:v>
                </c:pt>
                <c:pt idx="6">
                  <c:v>44.64</c:v>
                </c:pt>
                <c:pt idx="7">
                  <c:v>61.21</c:v>
                </c:pt>
                <c:pt idx="8">
                  <c:v>108.1</c:v>
                </c:pt>
                <c:pt idx="9">
                  <c:v>139.26</c:v>
                </c:pt>
                <c:pt idx="10">
                  <c:v>153.9</c:v>
                </c:pt>
                <c:pt idx="11">
                  <c:v>159.75</c:v>
                </c:pt>
                <c:pt idx="12">
                  <c:v>77.58</c:v>
                </c:pt>
                <c:pt idx="13">
                  <c:v>103.64</c:v>
                </c:pt>
                <c:pt idx="14">
                  <c:v>125.96</c:v>
                </c:pt>
                <c:pt idx="15">
                  <c:v>71.13</c:v>
                </c:pt>
                <c:pt idx="16">
                  <c:v>41.05</c:v>
                </c:pt>
              </c:numCache>
            </c:numRef>
          </c:val>
        </c:ser>
        <c:ser>
          <c:idx val="1"/>
          <c:order val="1"/>
          <c:tx>
            <c:strRef>
              <c:f>'n nodules papier'!$E$4</c:f>
              <c:strCache>
                <c:ptCount val="1"/>
                <c:pt idx="0">
                  <c:v>Btai1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 nodules papier'!$K$27:$K$43</c:f>
                <c:numCache>
                  <c:formatCode>General</c:formatCode>
                  <c:ptCount val="17"/>
                  <c:pt idx="0">
                    <c:v>10.8</c:v>
                  </c:pt>
                  <c:pt idx="1">
                    <c:v>14.42</c:v>
                  </c:pt>
                  <c:pt idx="2">
                    <c:v>8.67</c:v>
                  </c:pt>
                  <c:pt idx="3">
                    <c:v>5.81</c:v>
                  </c:pt>
                  <c:pt idx="4">
                    <c:v>8.58</c:v>
                  </c:pt>
                  <c:pt idx="5">
                    <c:v>12.7</c:v>
                  </c:pt>
                  <c:pt idx="6">
                    <c:v>10.119999999999999</c:v>
                  </c:pt>
                  <c:pt idx="7">
                    <c:v>7.54</c:v>
                  </c:pt>
                  <c:pt idx="8">
                    <c:v>28.28</c:v>
                  </c:pt>
                  <c:pt idx="9">
                    <c:v>18.55</c:v>
                  </c:pt>
                  <c:pt idx="10">
                    <c:v>22.93</c:v>
                  </c:pt>
                  <c:pt idx="11">
                    <c:v>11.07</c:v>
                  </c:pt>
                  <c:pt idx="12">
                    <c:v>13.92</c:v>
                  </c:pt>
                  <c:pt idx="13">
                    <c:v>25.56</c:v>
                  </c:pt>
                  <c:pt idx="14">
                    <c:v>9.06</c:v>
                  </c:pt>
                  <c:pt idx="15">
                    <c:v>21.91</c:v>
                  </c:pt>
                  <c:pt idx="16">
                    <c:v>3.58</c:v>
                  </c:pt>
                </c:numCache>
              </c:numRef>
            </c:plus>
            <c:minus>
              <c:numRef>
                <c:f>'n nodules papier'!$K$27:$K$43</c:f>
                <c:numCache>
                  <c:formatCode>General</c:formatCode>
                  <c:ptCount val="17"/>
                  <c:pt idx="0">
                    <c:v>10.8</c:v>
                  </c:pt>
                  <c:pt idx="1">
                    <c:v>14.42</c:v>
                  </c:pt>
                  <c:pt idx="2">
                    <c:v>8.67</c:v>
                  </c:pt>
                  <c:pt idx="3">
                    <c:v>5.81</c:v>
                  </c:pt>
                  <c:pt idx="4">
                    <c:v>8.58</c:v>
                  </c:pt>
                  <c:pt idx="5">
                    <c:v>12.7</c:v>
                  </c:pt>
                  <c:pt idx="6">
                    <c:v>10.119999999999999</c:v>
                  </c:pt>
                  <c:pt idx="7">
                    <c:v>7.54</c:v>
                  </c:pt>
                  <c:pt idx="8">
                    <c:v>28.28</c:v>
                  </c:pt>
                  <c:pt idx="9">
                    <c:v>18.55</c:v>
                  </c:pt>
                  <c:pt idx="10">
                    <c:v>22.93</c:v>
                  </c:pt>
                  <c:pt idx="11">
                    <c:v>11.07</c:v>
                  </c:pt>
                  <c:pt idx="12">
                    <c:v>13.92</c:v>
                  </c:pt>
                  <c:pt idx="13">
                    <c:v>25.56</c:v>
                  </c:pt>
                  <c:pt idx="14">
                    <c:v>9.06</c:v>
                  </c:pt>
                  <c:pt idx="15">
                    <c:v>21.91</c:v>
                  </c:pt>
                  <c:pt idx="16">
                    <c:v>3.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n nodules papier'!$B$5:$C$21</c:f>
              <c:multiLvlStrCache>
                <c:ptCount val="17"/>
                <c:lvl>
                  <c:pt idx="0">
                    <c:v>n°75</c:v>
                  </c:pt>
                  <c:pt idx="1">
                    <c:v>n°80</c:v>
                  </c:pt>
                  <c:pt idx="2">
                    <c:v>n°101</c:v>
                  </c:pt>
                  <c:pt idx="3">
                    <c:v>n°108</c:v>
                  </c:pt>
                  <c:pt idx="4">
                    <c:v>n°109</c:v>
                  </c:pt>
                  <c:pt idx="5">
                    <c:v>n°20</c:v>
                  </c:pt>
                  <c:pt idx="6">
                    <c:v>n°92</c:v>
                  </c:pt>
                  <c:pt idx="7">
                    <c:v>n°95</c:v>
                  </c:pt>
                  <c:pt idx="8">
                    <c:v>n°105</c:v>
                  </c:pt>
                  <c:pt idx="9">
                    <c:v>n°19</c:v>
                  </c:pt>
                  <c:pt idx="10">
                    <c:v>n°29</c:v>
                  </c:pt>
                  <c:pt idx="11">
                    <c:v>n°44</c:v>
                  </c:pt>
                  <c:pt idx="12">
                    <c:v>n°93</c:v>
                  </c:pt>
                  <c:pt idx="13">
                    <c:v>n°97</c:v>
                  </c:pt>
                  <c:pt idx="14">
                    <c:v>n°98</c:v>
                  </c:pt>
                  <c:pt idx="15">
                    <c:v>n°22</c:v>
                  </c:pt>
                  <c:pt idx="16">
                    <c:v>n°100</c:v>
                  </c:pt>
                </c:lvl>
                <c:lvl>
                  <c:pt idx="0">
                    <c:v>A. evenia ss</c:v>
                  </c:pt>
                  <c:pt idx="5">
                    <c:v>A. indica 4x</c:v>
                  </c:pt>
                  <c:pt idx="9">
                    <c:v>A. indica 6x                                                  Africa</c:v>
                  </c:pt>
                  <c:pt idx="15">
                    <c:v>A. indica 6x Australia</c:v>
                  </c:pt>
                </c:lvl>
              </c:multiLvlStrCache>
            </c:multiLvlStrRef>
          </c:cat>
          <c:val>
            <c:numRef>
              <c:f>'n nodules papier'!$E$27:$E$43</c:f>
              <c:numCache>
                <c:formatCode>General</c:formatCode>
                <c:ptCount val="17"/>
                <c:pt idx="0">
                  <c:v>57.13</c:v>
                </c:pt>
                <c:pt idx="1">
                  <c:v>62.7</c:v>
                </c:pt>
                <c:pt idx="2">
                  <c:v>22.6</c:v>
                </c:pt>
                <c:pt idx="3">
                  <c:v>24.52</c:v>
                </c:pt>
                <c:pt idx="4">
                  <c:v>50.05</c:v>
                </c:pt>
                <c:pt idx="5">
                  <c:v>44.59</c:v>
                </c:pt>
                <c:pt idx="6">
                  <c:v>16.809999999999999</c:v>
                </c:pt>
                <c:pt idx="7">
                  <c:v>45.17</c:v>
                </c:pt>
                <c:pt idx="8">
                  <c:v>94.8</c:v>
                </c:pt>
                <c:pt idx="9">
                  <c:v>32.99</c:v>
                </c:pt>
                <c:pt idx="10">
                  <c:v>91.52</c:v>
                </c:pt>
                <c:pt idx="11">
                  <c:v>61.7</c:v>
                </c:pt>
                <c:pt idx="12">
                  <c:v>55.32</c:v>
                </c:pt>
                <c:pt idx="13">
                  <c:v>59.15</c:v>
                </c:pt>
                <c:pt idx="14">
                  <c:v>68.489999999999995</c:v>
                </c:pt>
                <c:pt idx="15">
                  <c:v>59.1</c:v>
                </c:pt>
                <c:pt idx="16">
                  <c:v>36.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04251664"/>
        <c:axId val="304250880"/>
      </c:barChart>
      <c:catAx>
        <c:axId val="304251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04250880"/>
        <c:crosses val="autoZero"/>
        <c:auto val="1"/>
        <c:lblAlgn val="ctr"/>
        <c:lblOffset val="100"/>
        <c:noMultiLvlLbl val="0"/>
      </c:catAx>
      <c:valAx>
        <c:axId val="304250880"/>
        <c:scaling>
          <c:orientation val="minMax"/>
          <c:max val="2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RA (A.U.)</a:t>
                </a:r>
              </a:p>
            </c:rich>
          </c:tx>
          <c:layout>
            <c:manualLayout>
              <c:xMode val="edge"/>
              <c:yMode val="edge"/>
              <c:x val="1.4481189851268592E-2"/>
              <c:y val="0.3516311395654982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304251664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5480028632784544"/>
          <c:y val="5.8383496455466422E-2"/>
          <c:w val="0.12027185238208861"/>
          <c:h val="0.147570011692463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5295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1119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091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0932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9605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019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2491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5896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0085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2424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5031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A9E3B-90AF-4A9B-AA88-309CA57CD5DF}" type="datetimeFigureOut">
              <a:rPr lang="fr-FR" smtClean="0"/>
              <a:t>14/09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B74B8B-A1BD-44E5-BCE6-BED6C5F0B98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1281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7" name="Rectangle 25"/>
          <p:cNvSpPr>
            <a:spLocks noChangeArrowheads="1"/>
          </p:cNvSpPr>
          <p:nvPr/>
        </p:nvSpPr>
        <p:spPr bwMode="auto">
          <a:xfrm>
            <a:off x="246515" y="1331640"/>
            <a:ext cx="21602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200" b="1" dirty="0" smtClean="0">
                <a:solidFill>
                  <a:srgbClr val="000000"/>
                </a:solidFill>
              </a:rPr>
              <a:t>(a)</a:t>
            </a:r>
            <a:endParaRPr kumimoji="0" lang="fr-FR" altLang="fr-FR" sz="1200" b="1" u="none" strike="noStrike" cap="none" normalizeH="0" dirty="0" smtClean="0">
              <a:ln>
                <a:noFill/>
              </a:ln>
              <a:solidFill>
                <a:srgbClr val="000000"/>
              </a:solidFill>
              <a:effectLst/>
            </a:endParaRPr>
          </a:p>
        </p:txBody>
      </p:sp>
      <p:sp>
        <p:nvSpPr>
          <p:cNvPr id="918" name="Rectangle 25"/>
          <p:cNvSpPr>
            <a:spLocks noChangeArrowheads="1"/>
          </p:cNvSpPr>
          <p:nvPr/>
        </p:nvSpPr>
        <p:spPr bwMode="auto">
          <a:xfrm>
            <a:off x="246515" y="4243318"/>
            <a:ext cx="21602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200" b="1" dirty="0" smtClean="0">
                <a:solidFill>
                  <a:srgbClr val="000000"/>
                </a:solidFill>
              </a:rPr>
              <a:t>(b)</a:t>
            </a:r>
            <a:endParaRPr kumimoji="0" lang="fr-FR" altLang="fr-FR" sz="1200" b="1" u="none" strike="noStrike" cap="none" normalizeH="0" dirty="0" smtClean="0">
              <a:ln>
                <a:noFill/>
              </a:ln>
              <a:solidFill>
                <a:srgbClr val="000000"/>
              </a:solidFill>
              <a:effectLst/>
            </a:endParaRPr>
          </a:p>
        </p:txBody>
      </p:sp>
      <p:graphicFrame>
        <p:nvGraphicFramePr>
          <p:cNvPr id="573" name="Graphique 57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277407"/>
              </p:ext>
            </p:extLst>
          </p:nvPr>
        </p:nvGraphicFramePr>
        <p:xfrm>
          <a:off x="246515" y="1309484"/>
          <a:ext cx="6286500" cy="3057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74" name="Graphique 57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1417784"/>
              </p:ext>
            </p:extLst>
          </p:nvPr>
        </p:nvGraphicFramePr>
        <p:xfrm>
          <a:off x="228819" y="4211960"/>
          <a:ext cx="6286500" cy="3057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42797009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7</TotalTime>
  <Words>12</Words>
  <Application>Microsoft Office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67</cp:revision>
  <dcterms:created xsi:type="dcterms:W3CDTF">2016-11-24T13:36:01Z</dcterms:created>
  <dcterms:modified xsi:type="dcterms:W3CDTF">2017-09-14T06:59:49Z</dcterms:modified>
</cp:coreProperties>
</file>